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16632" y="98212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4" name="Picture 2" descr="C:\Users\ImageQuant\Desktop\Sonomi\Fstl1\2. NRFB\Fstl1 CM vs FB\Ad-Fstl1_B_2-18-2016\mFstl1 polyclonal\mFstl1_highresolution 20160219_1328_3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64" y="539552"/>
            <a:ext cx="2468877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ImageQuant\Desktop\Sonomi\Fstl1\2. NRFB\Fstl1 CM vs FB\Ad-Fstl1_B_2-18-2016\mFstl1 polyclonal\MK 20160219_1329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6344" y="539552"/>
            <a:ext cx="24688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1"/>
          <p:cNvSpPr txBox="1"/>
          <p:nvPr/>
        </p:nvSpPr>
        <p:spPr>
          <a:xfrm>
            <a:off x="116632" y="2402468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6" name="Picture 4" descr="C:\Users\ImageQuant\Desktop\Sonomi\Fstl1\2. NRFB\Fstl1 CM vs FB\rec Fstl1 proteins\human poly Fstl1 R&amp;D\human Fstl1 high resolution 20160222_1518_8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362" y="2828950"/>
            <a:ext cx="24688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ImageQuant\Desktop\Sonomi\Fstl1\2. NRFB\Fstl1 CM vs FB\rec Fstl1 proteins\mouse polyclonal Fstl1Ab 20160219_1334_2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4336" y="2828950"/>
            <a:ext cx="24688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ImageQuant\Desktop\Sonomi\Fstl1\2. NRFB\Fstl1 CM vs FB\rec Fstl1 proteins\MK 20160219_1337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4778" y="4505325"/>
            <a:ext cx="24688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正方形/長方形 22"/>
          <p:cNvSpPr/>
          <p:nvPr/>
        </p:nvSpPr>
        <p:spPr>
          <a:xfrm>
            <a:off x="929986" y="1354350"/>
            <a:ext cx="1190217" cy="39267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テキスト ボックス 23"/>
          <p:cNvSpPr txBox="1"/>
          <p:nvPr/>
        </p:nvSpPr>
        <p:spPr>
          <a:xfrm>
            <a:off x="908720" y="1043608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use Fstl1 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22"/>
          <p:cNvSpPr/>
          <p:nvPr/>
        </p:nvSpPr>
        <p:spPr>
          <a:xfrm>
            <a:off x="3100859" y="1350483"/>
            <a:ext cx="313422" cy="39267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テキスト ボックス 23"/>
          <p:cNvSpPr txBox="1"/>
          <p:nvPr/>
        </p:nvSpPr>
        <p:spPr>
          <a:xfrm>
            <a:off x="3085510" y="61156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K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22"/>
          <p:cNvSpPr/>
          <p:nvPr/>
        </p:nvSpPr>
        <p:spPr>
          <a:xfrm>
            <a:off x="1639325" y="3442582"/>
            <a:ext cx="739031" cy="39267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テキスト ボックス 23"/>
          <p:cNvSpPr txBox="1"/>
          <p:nvPr/>
        </p:nvSpPr>
        <p:spPr>
          <a:xfrm>
            <a:off x="1484784" y="3163739"/>
            <a:ext cx="1141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man Fstl1 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22"/>
          <p:cNvSpPr/>
          <p:nvPr/>
        </p:nvSpPr>
        <p:spPr>
          <a:xfrm>
            <a:off x="4159605" y="3440159"/>
            <a:ext cx="739031" cy="39267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テキスト ボックス 23"/>
          <p:cNvSpPr txBox="1"/>
          <p:nvPr/>
        </p:nvSpPr>
        <p:spPr>
          <a:xfrm>
            <a:off x="4005064" y="3161316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use Fstl1 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22"/>
          <p:cNvSpPr/>
          <p:nvPr/>
        </p:nvSpPr>
        <p:spPr>
          <a:xfrm>
            <a:off x="3165314" y="5034426"/>
            <a:ext cx="146214" cy="431937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テキスト ボックス 23"/>
          <p:cNvSpPr txBox="1"/>
          <p:nvPr/>
        </p:nvSpPr>
        <p:spPr>
          <a:xfrm>
            <a:off x="3060750" y="4788392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K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22"/>
          <p:cNvSpPr/>
          <p:nvPr/>
        </p:nvSpPr>
        <p:spPr>
          <a:xfrm>
            <a:off x="680540" y="3402567"/>
            <a:ext cx="146214" cy="431937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テキスト ボックス 23"/>
          <p:cNvSpPr txBox="1"/>
          <p:nvPr/>
        </p:nvSpPr>
        <p:spPr>
          <a:xfrm>
            <a:off x="575976" y="315653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K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4721209"/>
              </p:ext>
            </p:extLst>
          </p:nvPr>
        </p:nvGraphicFramePr>
        <p:xfrm>
          <a:off x="116253" y="6787934"/>
          <a:ext cx="6590149" cy="13788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7738"/>
                <a:gridCol w="545681"/>
                <a:gridCol w="559673"/>
                <a:gridCol w="559673"/>
                <a:gridCol w="559673"/>
                <a:gridCol w="559673"/>
                <a:gridCol w="559673"/>
                <a:gridCol w="559673"/>
                <a:gridCol w="559673"/>
                <a:gridCol w="559673"/>
                <a:gridCol w="559673"/>
                <a:gridCol w="559673"/>
              </a:tblGrid>
              <a:tr h="2146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gure EV. 5C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  <a:tr h="198153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ell migration assay (%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  <a:tr h="198153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ontro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91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9.45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.04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6.93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94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.11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3.40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77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49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3.59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  <a:tr h="37153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Insect cell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31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7.62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9.79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1.68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03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09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1.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6.71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8.78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8.33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  <a:tr h="198153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HEK2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8.16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5.7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2.65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7.10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2.06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0.12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0.59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6.47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3.68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.61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  <a:tr h="198153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E.Col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1.69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5.61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5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78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0.7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6.7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1.25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7.75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6.04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30.50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09" marR="6309" marT="6309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964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70</Words>
  <Application>Microsoft Office PowerPoint</Application>
  <PresentationFormat>On-screen Show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5:26Z</dcterms:modified>
</cp:coreProperties>
</file>